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3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-1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2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/>
              <a:t> IGB signals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2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coun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9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ble). The WIG file for IGB was provided in GEO database (accession number </a:t>
            </a:r>
            <a:r>
              <a:rPr lang="en-US" sz="1000" dirty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7205" y="1122002"/>
            <a:ext cx="1704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1A2.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802" y="372811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10D9.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5874" y="6385138"/>
            <a:ext cx="19559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ZK1240.8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240.1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107" y="1364223"/>
            <a:ext cx="4821539" cy="232615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864274" y="3160691"/>
            <a:ext cx="723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1A2.5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91" y="3995025"/>
            <a:ext cx="4821539" cy="2326154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4066422" y="5677647"/>
            <a:ext cx="737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10D9.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360" y="6725306"/>
            <a:ext cx="4821539" cy="232615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334475" y="8608600"/>
            <a:ext cx="7906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240.8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305342" y="8608600"/>
            <a:ext cx="7906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K1240.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294228" y="1369117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363661" y="4038650"/>
            <a:ext cx="1152195" cy="1421772"/>
            <a:chOff x="470526" y="6079802"/>
            <a:chExt cx="1152195" cy="1421772"/>
          </a:xfrm>
        </p:grpSpPr>
        <p:sp>
          <p:nvSpPr>
            <p:cNvPr id="44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63660" y="6708956"/>
            <a:ext cx="1152195" cy="1421772"/>
            <a:chOff x="470526" y="6079802"/>
            <a:chExt cx="1152195" cy="1421772"/>
          </a:xfrm>
        </p:grpSpPr>
        <p:sp>
          <p:nvSpPr>
            <p:cNvPr id="49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43C11.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7" y="264516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7D4.2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zyg-9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01" y="277778"/>
            <a:ext cx="4821539" cy="232615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260428" y="2147586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43C11.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553" y="2946653"/>
            <a:ext cx="482153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635040" y="472798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7D4.2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553" y="5645962"/>
            <a:ext cx="4821539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716618" y="7495592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zyg-9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329931" y="197959"/>
            <a:ext cx="1152195" cy="1421772"/>
            <a:chOff x="470526" y="6079802"/>
            <a:chExt cx="1152195" cy="1421772"/>
          </a:xfrm>
        </p:grpSpPr>
        <p:sp>
          <p:nvSpPr>
            <p:cNvPr id="3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379361" y="2850582"/>
            <a:ext cx="1152195" cy="1421772"/>
            <a:chOff x="470526" y="6079802"/>
            <a:chExt cx="1152195" cy="1421772"/>
          </a:xfrm>
        </p:grpSpPr>
        <p:sp>
          <p:nvSpPr>
            <p:cNvPr id="45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80832" y="5554386"/>
            <a:ext cx="1152195" cy="1421772"/>
            <a:chOff x="470526" y="6079802"/>
            <a:chExt cx="1152195" cy="1421772"/>
          </a:xfrm>
        </p:grpSpPr>
        <p:sp>
          <p:nvSpPr>
            <p:cNvPr id="5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307.7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4D5.12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16842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I) F44E5.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44E5.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01" y="299778"/>
            <a:ext cx="4821539" cy="2326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4378018" y="1963978"/>
            <a:ext cx="830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307.7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968" y="2932072"/>
            <a:ext cx="4821539" cy="232615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95020" y="4741740"/>
            <a:ext cx="871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4D5.1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5680529"/>
            <a:ext cx="4821539" cy="232615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2968434" y="7284152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44E5.5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839355" y="726162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44E5.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336362" y="268860"/>
            <a:ext cx="1152195" cy="1421772"/>
            <a:chOff x="470526" y="6079802"/>
            <a:chExt cx="1152195" cy="1421772"/>
          </a:xfrm>
        </p:grpSpPr>
        <p:sp>
          <p:nvSpPr>
            <p:cNvPr id="3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336362" y="2910623"/>
            <a:ext cx="1152195" cy="1421772"/>
            <a:chOff x="470526" y="6079802"/>
            <a:chExt cx="1152195" cy="1421772"/>
          </a:xfrm>
        </p:grpSpPr>
        <p:sp>
          <p:nvSpPr>
            <p:cNvPr id="4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352719" y="5662890"/>
            <a:ext cx="1152195" cy="1421772"/>
            <a:chOff x="470526" y="6079802"/>
            <a:chExt cx="1152195" cy="1421772"/>
          </a:xfrm>
        </p:grpSpPr>
        <p:sp>
          <p:nvSpPr>
            <p:cNvPr id="52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J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38E10A.2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urf-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og-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99" y="260526"/>
            <a:ext cx="4821539" cy="2326154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1051849" y="1881207"/>
            <a:ext cx="1043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38E10A.2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99" y="2910452"/>
            <a:ext cx="4821539" cy="232615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1488557" y="4509791"/>
            <a:ext cx="879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urf-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139" y="5643235"/>
            <a:ext cx="4821539" cy="2326154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1071167" y="7154766"/>
            <a:ext cx="6646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og-4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71833" y="278971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421263" y="2903117"/>
            <a:ext cx="1152195" cy="1421772"/>
            <a:chOff x="470526" y="6079802"/>
            <a:chExt cx="1152195" cy="1421772"/>
          </a:xfrm>
        </p:grpSpPr>
        <p:sp>
          <p:nvSpPr>
            <p:cNvPr id="4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71833" y="5643235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26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M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3F4B.10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321498"/>
            <a:ext cx="482153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909597" y="2179574"/>
            <a:ext cx="8868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3F4B.10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341057" y="263748"/>
            <a:ext cx="1152195" cy="1421772"/>
            <a:chOff x="470526" y="6079802"/>
            <a:chExt cx="1152195" cy="1421772"/>
          </a:xfrm>
        </p:grpSpPr>
        <p:sp>
          <p:nvSpPr>
            <p:cNvPr id="1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8162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</TotalTime>
  <Words>233</Words>
  <Application>Microsoft Office PowerPoint</Application>
  <PresentationFormat>On-screen Show (4:3)</PresentationFormat>
  <Paragraphs>8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41</cp:revision>
  <cp:lastPrinted>2023-01-23T06:24:09Z</cp:lastPrinted>
  <dcterms:created xsi:type="dcterms:W3CDTF">2023-01-23T06:15:50Z</dcterms:created>
  <dcterms:modified xsi:type="dcterms:W3CDTF">2023-10-23T07:43:58Z</dcterms:modified>
</cp:coreProperties>
</file>